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2B024-2266-40CE-9B67-FD38526327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0CF93-F1CC-43CF-B532-2A8474C583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6931B-2819-411E-89C8-72CABA0D71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12E2C-BBA2-4C90-A64A-5C113A6821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0DFB9-AACE-4624-97A6-C6D2735275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2686F0-41F7-412C-86D3-10E6ACF30C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69873-1DE0-40C7-8168-9BE26DD04F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1DD58-17FC-4EFC-AC27-D1C214BF71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C3197-C54D-47A4-9C5C-132187FFA9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3FA33-82A7-4F2E-B3DF-5553D0C73F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DB42C-197D-4543-8874-1F397F0283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46591-19E6-406B-A014-8DDF4C16B3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2D7FB0-A1B1-4BCC-84BC-9713142276AE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843280" y="765000"/>
            <a:ext cx="3778200" cy="58057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17360" y="0"/>
            <a:ext cx="8813880" cy="154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The green (CPU), blue (AcbC) and red (AcbSh) square panels represent the areas where the </a:t>
            </a:r>
            <a:r>
              <a:rPr b="0" i="1" lang="en-GB" sz="1400" spc="-1" strike="noStrike">
                <a:solidFill>
                  <a:srgbClr val="000000"/>
                </a:solidFill>
                <a:latin typeface="Arial"/>
              </a:rPr>
              <a:t>in situ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proximity ligation assay microphotographs were taken.  Transverse sections of the rat striatum (Bregma level: 1.00 mm). The image is a modified figure taken from </a:t>
            </a: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The rat brain in stereotaxic coordinates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 by Paxinos and Watson. Second Edition. Academic Press, 1986. COU: caudate putamen, AcbSH: accumbens shell; AcbC: accumbens co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3448080" y="1700280"/>
            <a:ext cx="5692680" cy="4941720"/>
            <a:chOff x="3448080" y="1700280"/>
            <a:chExt cx="5692680" cy="4941720"/>
          </a:xfrm>
        </p:grpSpPr>
        <p:sp>
          <p:nvSpPr>
            <p:cNvPr id="44" name=""/>
            <p:cNvSpPr/>
            <p:nvPr/>
          </p:nvSpPr>
          <p:spPr>
            <a:xfrm>
              <a:off x="3851280" y="2349360"/>
              <a:ext cx="503280" cy="505080"/>
            </a:xfrm>
            <a:prstGeom prst="rect">
              <a:avLst/>
            </a:prstGeom>
            <a:solidFill>
              <a:srgbClr val="99cc00">
                <a:alpha val="75000"/>
              </a:srgbClr>
            </a:solidFill>
            <a:ln w="2232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780000" y="5286240"/>
              <a:ext cx="504720" cy="289080"/>
            </a:xfrm>
            <a:prstGeom prst="rect">
              <a:avLst/>
            </a:prstGeom>
            <a:solidFill>
              <a:srgbClr val="000080">
                <a:alpha val="73000"/>
              </a:srgbClr>
            </a:solidFill>
            <a:ln w="1260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500720" y="4581360"/>
              <a:ext cx="288720" cy="217800"/>
            </a:xfrm>
            <a:prstGeom prst="rect">
              <a:avLst/>
            </a:prstGeom>
            <a:solidFill>
              <a:srgbClr val="0000ff">
                <a:alpha val="34000"/>
              </a:srgbClr>
            </a:solidFill>
            <a:ln w="12600">
              <a:solidFill>
                <a:srgbClr val="ff66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211640" y="4292640"/>
              <a:ext cx="289080" cy="217440"/>
            </a:xfrm>
            <a:prstGeom prst="rect">
              <a:avLst/>
            </a:prstGeom>
            <a:solidFill>
              <a:srgbClr val="0000ff">
                <a:alpha val="34000"/>
              </a:srgbClr>
            </a:solidFill>
            <a:ln w="12600">
              <a:solidFill>
                <a:srgbClr val="ff66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7134120" y="6273720"/>
              <a:ext cx="200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000000"/>
                  </a:solidFill>
                  <a:latin typeface="Arial"/>
                </a:rPr>
                <a:t>Bregma 1.00 m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851280" y="3141720"/>
              <a:ext cx="503280" cy="504720"/>
            </a:xfrm>
            <a:prstGeom prst="rect">
              <a:avLst/>
            </a:prstGeom>
            <a:solidFill>
              <a:srgbClr val="99cc00">
                <a:alpha val="75000"/>
              </a:srgbClr>
            </a:solidFill>
            <a:ln w="2232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292720" y="3789360"/>
              <a:ext cx="503280" cy="504720"/>
            </a:xfrm>
            <a:prstGeom prst="rect">
              <a:avLst/>
            </a:prstGeom>
            <a:solidFill>
              <a:srgbClr val="99cc00">
                <a:alpha val="75000"/>
              </a:srgbClr>
            </a:solidFill>
            <a:ln w="2232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076720" y="1844640"/>
              <a:ext cx="503280" cy="504720"/>
            </a:xfrm>
            <a:prstGeom prst="rect">
              <a:avLst/>
            </a:prstGeom>
            <a:solidFill>
              <a:srgbClr val="99cc00">
                <a:alpha val="75000"/>
              </a:srgbClr>
            </a:solidFill>
            <a:ln w="2232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580000" y="2492280"/>
              <a:ext cx="503280" cy="505080"/>
            </a:xfrm>
            <a:prstGeom prst="rect">
              <a:avLst/>
            </a:prstGeom>
            <a:solidFill>
              <a:srgbClr val="99cc00">
                <a:alpha val="75000"/>
              </a:srgbClr>
            </a:solidFill>
            <a:ln w="2232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356000" y="5013360"/>
              <a:ext cx="289080" cy="217440"/>
            </a:xfrm>
            <a:prstGeom prst="rect">
              <a:avLst/>
            </a:prstGeom>
            <a:solidFill>
              <a:srgbClr val="0000ff">
                <a:alpha val="34000"/>
              </a:srgbClr>
            </a:solidFill>
            <a:ln w="12600">
              <a:solidFill>
                <a:srgbClr val="ff66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860640" y="4491000"/>
              <a:ext cx="144720" cy="217440"/>
            </a:xfrm>
            <a:prstGeom prst="rect">
              <a:avLst/>
            </a:prstGeom>
            <a:solidFill>
              <a:srgbClr val="0000ff">
                <a:alpha val="34000"/>
              </a:srgbClr>
            </a:solidFill>
            <a:ln w="12600">
              <a:solidFill>
                <a:srgbClr val="ff66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338720" y="5300640"/>
              <a:ext cx="504720" cy="289080"/>
            </a:xfrm>
            <a:prstGeom prst="rect">
              <a:avLst/>
            </a:prstGeom>
            <a:solidFill>
              <a:srgbClr val="000080">
                <a:alpha val="73000"/>
              </a:srgbClr>
            </a:solidFill>
            <a:ln w="1260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506760" y="4940280"/>
              <a:ext cx="360360" cy="289080"/>
            </a:xfrm>
            <a:prstGeom prst="rect">
              <a:avLst/>
            </a:prstGeom>
            <a:solidFill>
              <a:srgbClr val="000080">
                <a:alpha val="73000"/>
              </a:srgbClr>
            </a:solidFill>
            <a:ln w="1260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448080" y="4451400"/>
              <a:ext cx="288720" cy="288720"/>
            </a:xfrm>
            <a:prstGeom prst="rect">
              <a:avLst/>
            </a:prstGeom>
            <a:solidFill>
              <a:srgbClr val="000080">
                <a:alpha val="73000"/>
              </a:srgbClr>
            </a:solidFill>
            <a:ln w="1260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500720" y="2349360"/>
              <a:ext cx="502920" cy="505080"/>
            </a:xfrm>
            <a:prstGeom prst="rect">
              <a:avLst/>
            </a:prstGeom>
            <a:solidFill>
              <a:srgbClr val="99cc00">
                <a:alpha val="75000"/>
              </a:srgbClr>
            </a:solidFill>
            <a:ln w="2232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140360" y="1700280"/>
              <a:ext cx="502920" cy="504720"/>
            </a:xfrm>
            <a:prstGeom prst="rect">
              <a:avLst/>
            </a:prstGeom>
            <a:solidFill>
              <a:srgbClr val="99cc00">
                <a:alpha val="75000"/>
              </a:srgbClr>
            </a:solidFill>
            <a:ln w="22320">
              <a:solidFill>
                <a:srgbClr val="ffcc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1T09:05:34Z</dcterms:created>
  <dc:creator>Dasiel Oscar Borroto Escuela</dc:creator>
  <dc:description/>
  <dc:language>en-US</dc:language>
  <cp:lastModifiedBy>Dasiel Oscar Borroto Escuela</cp:lastModifiedBy>
  <dcterms:modified xsi:type="dcterms:W3CDTF">2017-09-29T14:24:49Z</dcterms:modified>
  <cp:revision>55</cp:revision>
  <dc:subject/>
  <dc:title>Diapositiva 1</dc:title>
</cp:coreProperties>
</file>